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67" d="100"/>
          <a:sy n="67" d="100"/>
        </p:scale>
        <p:origin x="572" y="4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2DFB6-59EB-4E20-8F58-8A57F416DC5D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368BC-73C0-423F-8CD8-023D4B59EA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240724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2DFB6-59EB-4E20-8F58-8A57F416DC5D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368BC-73C0-423F-8CD8-023D4B59EA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662467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2DFB6-59EB-4E20-8F58-8A57F416DC5D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368BC-73C0-423F-8CD8-023D4B59EA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908725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2DFB6-59EB-4E20-8F58-8A57F416DC5D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368BC-73C0-423F-8CD8-023D4B59EA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493873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2DFB6-59EB-4E20-8F58-8A57F416DC5D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368BC-73C0-423F-8CD8-023D4B59EA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552384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2DFB6-59EB-4E20-8F58-8A57F416DC5D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368BC-73C0-423F-8CD8-023D4B59EA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50366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2DFB6-59EB-4E20-8F58-8A57F416DC5D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368BC-73C0-423F-8CD8-023D4B59EA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280248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2DFB6-59EB-4E20-8F58-8A57F416DC5D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368BC-73C0-423F-8CD8-023D4B59EA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72461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2DFB6-59EB-4E20-8F58-8A57F416DC5D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368BC-73C0-423F-8CD8-023D4B59EA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442953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2DFB6-59EB-4E20-8F58-8A57F416DC5D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368BC-73C0-423F-8CD8-023D4B59EA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364141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C2DFB6-59EB-4E20-8F58-8A57F416DC5D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6368BC-73C0-423F-8CD8-023D4B59EA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51267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C2DFB6-59EB-4E20-8F58-8A57F416DC5D}" type="datetimeFigureOut">
              <a:rPr lang="fr-FR" smtClean="0"/>
              <a:t>27/01/2025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6368BC-73C0-423F-8CD8-023D4B59EA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79013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666750" y="400050"/>
            <a:ext cx="19718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l Fig 1</a:t>
            </a:r>
            <a:endParaRPr lang="fr-FR" dirty="0"/>
          </a:p>
        </p:txBody>
      </p:sp>
      <p:pic>
        <p:nvPicPr>
          <p:cNvPr id="5" name="Image 4" descr="Une image contenant texte, capture d’écran&#10;&#10;Description générée automatiquement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8000" y="485775"/>
            <a:ext cx="5753100" cy="4343400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2876550" y="4829175"/>
            <a:ext cx="6096000" cy="1754326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="1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1. </a:t>
            </a:r>
            <a:r>
              <a:rPr lang="en-GB" sz="1200" b="1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xperimental design</a:t>
            </a:r>
            <a:r>
              <a:rPr lang="en-GB" sz="12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Overview of the study design comparing WT and double knock-in – </a:t>
            </a:r>
            <a:r>
              <a:rPr lang="en-GB" sz="1200" dirty="0" err="1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KI</a:t>
            </a:r>
            <a:r>
              <a:rPr lang="en-GB" sz="12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ice (n=17 per sex and genotype) at two different ages: 2 months and 4 months. </a:t>
            </a:r>
            <a:r>
              <a:rPr lang="en-GB" sz="1200" dirty="0" err="1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ehavioral</a:t>
            </a:r>
            <a:r>
              <a:rPr lang="en-GB" sz="12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ssessments, including the Object-in-Place test and Long-Term Object Recognition test, were conducted during weeks 1 and 2. Brain MRI scans were performed in weeks 3 and 4 using resting-state fMRI and T2-weighted protocols. The timeline shows </a:t>
            </a:r>
            <a:r>
              <a:rPr lang="en-GB" sz="1200" dirty="0" err="1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ehavioral</a:t>
            </a:r>
            <a:r>
              <a:rPr lang="en-GB" sz="12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esting preceding imaging for both age groups.  </a:t>
            </a:r>
            <a:endParaRPr lang="fr-F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9557655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1</Words>
  <Application>Microsoft Office PowerPoint</Application>
  <PresentationFormat>Grand écran</PresentationFormat>
  <Paragraphs>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Harsan</dc:creator>
  <cp:lastModifiedBy>Harsan</cp:lastModifiedBy>
  <cp:revision>2</cp:revision>
  <dcterms:created xsi:type="dcterms:W3CDTF">2025-01-27T21:50:00Z</dcterms:created>
  <dcterms:modified xsi:type="dcterms:W3CDTF">2025-01-27T21:50:39Z</dcterms:modified>
</cp:coreProperties>
</file>